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7B48EB-962E-4E89-947E-15E15B23609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AD4C6A-5C45-488C-BDEC-462DBC8EB1F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55CF23-F668-4916-AC6B-A5C355435A6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36639E-D0CA-45D4-AE69-A4A0BE5F7F3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F737AA-5729-4249-93ED-D8E4150B667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45DAE6-4E75-46E5-AAB9-861B0A1C76C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E7E7A5-CD5A-4109-BA29-9F091D56BE8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C4893C-303A-46EA-B975-3E00F4B5D12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6F7362-E8B4-4C82-905F-332401AF992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0D922E-9D0F-4C1D-88B3-BCCCAA7D9BF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DCBA59-FBF6-4CA4-B8F2-F7B696D5EFD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90E959-F44A-44AF-B51B-98D9732D49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23C5B7B-C92A-4B02-919B-F38CC85917B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3059280" y="1341360"/>
          <a:ext cx="2981160" cy="414360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059280" y="1341360"/>
                    <a:ext cx="2981160" cy="4143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3" name=""/>
          <p:cNvSpPr/>
          <p:nvPr/>
        </p:nvSpPr>
        <p:spPr>
          <a:xfrm>
            <a:off x="324000" y="5877000"/>
            <a:ext cx="84247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Additional File 4.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Vitamin B6 concentration (normalized to the Chl content) in tobacco leaves and in intact chloroplasts prepared from tobacco leaves. PN= pyridoxine; PM= pyridoxamine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7-01T15:53:07Z</dcterms:created>
  <dc:creator>havaux</dc:creator>
  <dc:description/>
  <dc:language>en-US</dc:language>
  <cp:lastModifiedBy>havaux</cp:lastModifiedBy>
  <dcterms:modified xsi:type="dcterms:W3CDTF">2009-10-27T10:37:44Z</dcterms:modified>
  <cp:revision>4</cp:revision>
  <dc:subject/>
  <dc:title>Diapositive 1</dc:title>
</cp:coreProperties>
</file>